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1" r:id="rId2"/>
    <p:sldId id="262" r:id="rId3"/>
    <p:sldId id="263" r:id="rId4"/>
  </p:sldIdLst>
  <p:sldSz cx="12192000" cy="6858000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6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5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齊藤 卓也" userId="535f7868ac294224" providerId="LiveId" clId="{B9B5C0D9-BAD6-4A31-A93F-B80F81530290}"/>
    <pc:docChg chg="delSld">
      <pc:chgData name="齊藤 卓也" userId="535f7868ac294224" providerId="LiveId" clId="{B9B5C0D9-BAD6-4A31-A93F-B80F81530290}" dt="2021-09-01T22:05:18.236" v="0" actId="2696"/>
      <pc:docMkLst>
        <pc:docMk/>
      </pc:docMkLst>
      <pc:sldChg chg="del">
        <pc:chgData name="齊藤 卓也" userId="535f7868ac294224" providerId="LiveId" clId="{B9B5C0D9-BAD6-4A31-A93F-B80F81530290}" dt="2021-09-01T22:05:18.236" v="0" actId="2696"/>
        <pc:sldMkLst>
          <pc:docMk/>
          <pc:sldMk cId="3449391951" sldId="260"/>
        </pc:sldMkLst>
      </pc:sldChg>
      <pc:sldChg chg="del">
        <pc:chgData name="齊藤 卓也" userId="535f7868ac294224" providerId="LiveId" clId="{B9B5C0D9-BAD6-4A31-A93F-B80F81530290}" dt="2021-09-01T22:05:18.236" v="0" actId="2696"/>
        <pc:sldMkLst>
          <pc:docMk/>
          <pc:sldMk cId="1896458787" sldId="627"/>
        </pc:sldMkLst>
      </pc:sldChg>
      <pc:sldChg chg="del">
        <pc:chgData name="齊藤 卓也" userId="535f7868ac294224" providerId="LiveId" clId="{B9B5C0D9-BAD6-4A31-A93F-B80F81530290}" dt="2021-09-01T22:05:18.236" v="0" actId="2696"/>
        <pc:sldMkLst>
          <pc:docMk/>
          <pc:sldMk cId="1250419399" sldId="628"/>
        </pc:sldMkLst>
      </pc:sldChg>
      <pc:sldChg chg="del">
        <pc:chgData name="齊藤 卓也" userId="535f7868ac294224" providerId="LiveId" clId="{B9B5C0D9-BAD6-4A31-A93F-B80F81530290}" dt="2021-09-01T22:05:18.236" v="0" actId="2696"/>
        <pc:sldMkLst>
          <pc:docMk/>
          <pc:sldMk cId="2266497160" sldId="629"/>
        </pc:sldMkLst>
      </pc:sldChg>
      <pc:sldChg chg="del">
        <pc:chgData name="齊藤 卓也" userId="535f7868ac294224" providerId="LiveId" clId="{B9B5C0D9-BAD6-4A31-A93F-B80F81530290}" dt="2021-09-01T22:05:18.236" v="0" actId="2696"/>
        <pc:sldMkLst>
          <pc:docMk/>
          <pc:sldMk cId="2931024107" sldId="630"/>
        </pc:sldMkLst>
      </pc:sldChg>
      <pc:sldMasterChg chg="delSldLayout">
        <pc:chgData name="齊藤 卓也" userId="535f7868ac294224" providerId="LiveId" clId="{B9B5C0D9-BAD6-4A31-A93F-B80F81530290}" dt="2021-09-01T22:05:18.236" v="0" actId="2696"/>
        <pc:sldMasterMkLst>
          <pc:docMk/>
          <pc:sldMasterMk cId="1941029775" sldId="2147483648"/>
        </pc:sldMasterMkLst>
        <pc:sldLayoutChg chg="del">
          <pc:chgData name="齊藤 卓也" userId="535f7868ac294224" providerId="LiveId" clId="{B9B5C0D9-BAD6-4A31-A93F-B80F81530290}" dt="2021-09-01T22:05:18.236" v="0" actId="2696"/>
          <pc:sldLayoutMkLst>
            <pc:docMk/>
            <pc:sldMasterMk cId="1941029775" sldId="2147483648"/>
            <pc:sldLayoutMk cId="433947141" sldId="2147483660"/>
          </pc:sldLayoutMkLst>
        </pc:sldLayoutChg>
      </pc:sldMasterChg>
    </pc:docChg>
  </pc:docChgLst>
  <pc:docChgLst>
    <pc:chgData name="齊藤 卓也" userId="535f7868ac294224" providerId="LiveId" clId="{9BDA931D-D391-4D52-8E92-27DD72B808DF}"/>
    <pc:docChg chg="undo custSel delSld modSld">
      <pc:chgData name="齊藤 卓也" userId="535f7868ac294224" providerId="LiveId" clId="{9BDA931D-D391-4D52-8E92-27DD72B808DF}" dt="2021-09-01T21:04:31.126" v="162" actId="20577"/>
      <pc:docMkLst>
        <pc:docMk/>
      </pc:docMkLst>
      <pc:sldChg chg="del">
        <pc:chgData name="齊藤 卓也" userId="535f7868ac294224" providerId="LiveId" clId="{9BDA931D-D391-4D52-8E92-27DD72B808DF}" dt="2021-08-29T09:34:49.027" v="0" actId="2696"/>
        <pc:sldMkLst>
          <pc:docMk/>
          <pc:sldMk cId="2112906168" sldId="257"/>
        </pc:sldMkLst>
      </pc:sldChg>
      <pc:sldChg chg="del">
        <pc:chgData name="齊藤 卓也" userId="535f7868ac294224" providerId="LiveId" clId="{9BDA931D-D391-4D52-8E92-27DD72B808DF}" dt="2021-08-29T09:34:49.027" v="0" actId="2696"/>
        <pc:sldMkLst>
          <pc:docMk/>
          <pc:sldMk cId="1853723729" sldId="259"/>
        </pc:sldMkLst>
      </pc:sldChg>
      <pc:sldChg chg="del">
        <pc:chgData name="齊藤 卓也" userId="535f7868ac294224" providerId="LiveId" clId="{9BDA931D-D391-4D52-8E92-27DD72B808DF}" dt="2021-08-29T09:38:37.124" v="1" actId="2696"/>
        <pc:sldMkLst>
          <pc:docMk/>
          <pc:sldMk cId="3449391951" sldId="260"/>
        </pc:sldMkLst>
      </pc:sldChg>
      <pc:sldChg chg="modSp del mod">
        <pc:chgData name="齊藤 卓也" userId="535f7868ac294224" providerId="LiveId" clId="{9BDA931D-D391-4D52-8E92-27DD72B808DF}" dt="2021-09-01T21:00:31.454" v="82" actId="20577"/>
        <pc:sldMkLst>
          <pc:docMk/>
          <pc:sldMk cId="650114600" sldId="261"/>
        </pc:sldMkLst>
        <pc:spChg chg="mod">
          <ac:chgData name="齊藤 卓也" userId="535f7868ac294224" providerId="LiveId" clId="{9BDA931D-D391-4D52-8E92-27DD72B808DF}" dt="2021-09-01T21:00:31.454" v="82" actId="20577"/>
          <ac:spMkLst>
            <pc:docMk/>
            <pc:sldMk cId="650114600" sldId="261"/>
            <ac:spMk id="6" creationId="{C1D21F52-B978-45EE-91C6-C7633F88A4E4}"/>
          </ac:spMkLst>
        </pc:spChg>
      </pc:sldChg>
      <pc:sldChg chg="modSp del mod">
        <pc:chgData name="齊藤 卓也" userId="535f7868ac294224" providerId="LiveId" clId="{9BDA931D-D391-4D52-8E92-27DD72B808DF}" dt="2021-09-01T21:03:35.520" v="125" actId="20577"/>
        <pc:sldMkLst>
          <pc:docMk/>
          <pc:sldMk cId="1462497610" sldId="262"/>
        </pc:sldMkLst>
        <pc:spChg chg="mod">
          <ac:chgData name="齊藤 卓也" userId="535f7868ac294224" providerId="LiveId" clId="{9BDA931D-D391-4D52-8E92-27DD72B808DF}" dt="2021-09-01T21:03:35.520" v="125" actId="20577"/>
          <ac:spMkLst>
            <pc:docMk/>
            <pc:sldMk cId="1462497610" sldId="262"/>
            <ac:spMk id="6" creationId="{AF4F3250-DD8D-4170-BBA3-0134202E31F8}"/>
          </ac:spMkLst>
        </pc:spChg>
      </pc:sldChg>
      <pc:sldChg chg="modSp del mod">
        <pc:chgData name="齊藤 卓也" userId="535f7868ac294224" providerId="LiveId" clId="{9BDA931D-D391-4D52-8E92-27DD72B808DF}" dt="2021-09-01T21:04:31.126" v="162" actId="20577"/>
        <pc:sldMkLst>
          <pc:docMk/>
          <pc:sldMk cId="1520655707" sldId="263"/>
        </pc:sldMkLst>
        <pc:spChg chg="mod">
          <ac:chgData name="齊藤 卓也" userId="535f7868ac294224" providerId="LiveId" clId="{9BDA931D-D391-4D52-8E92-27DD72B808DF}" dt="2021-09-01T21:04:31.126" v="162" actId="20577"/>
          <ac:spMkLst>
            <pc:docMk/>
            <pc:sldMk cId="1520655707" sldId="263"/>
            <ac:spMk id="6" creationId="{62240A5E-5AF0-42E0-89AB-2A333DF5CED1}"/>
          </ac:spMkLst>
        </pc:spChg>
      </pc:sldChg>
      <pc:sldChg chg="modSp mod">
        <pc:chgData name="齊藤 卓也" userId="535f7868ac294224" providerId="LiveId" clId="{9BDA931D-D391-4D52-8E92-27DD72B808DF}" dt="2021-08-29T09:39:16.759" v="7" actId="20577"/>
        <pc:sldMkLst>
          <pc:docMk/>
          <pc:sldMk cId="1896458787" sldId="627"/>
        </pc:sldMkLst>
        <pc:spChg chg="mod">
          <ac:chgData name="齊藤 卓也" userId="535f7868ac294224" providerId="LiveId" clId="{9BDA931D-D391-4D52-8E92-27DD72B808DF}" dt="2021-08-29T09:39:13.062" v="5" actId="20577"/>
          <ac:spMkLst>
            <pc:docMk/>
            <pc:sldMk cId="1896458787" sldId="627"/>
            <ac:spMk id="7" creationId="{F1E5C3C8-2147-480C-BA96-96042BC45248}"/>
          </ac:spMkLst>
        </pc:spChg>
        <pc:spChg chg="mod">
          <ac:chgData name="齊藤 卓也" userId="535f7868ac294224" providerId="LiveId" clId="{9BDA931D-D391-4D52-8E92-27DD72B808DF}" dt="2021-08-29T09:39:16.759" v="7" actId="20577"/>
          <ac:spMkLst>
            <pc:docMk/>
            <pc:sldMk cId="1896458787" sldId="627"/>
            <ac:spMk id="8" creationId="{C1D3C8C2-A69C-4895-AC92-406ABFD0EAE1}"/>
          </ac:spMkLst>
        </pc:spChg>
      </pc:sldChg>
      <pc:sldChg chg="modSp mod">
        <pc:chgData name="齊藤 卓也" userId="535f7868ac294224" providerId="LiveId" clId="{9BDA931D-D391-4D52-8E92-27DD72B808DF}" dt="2021-08-29T09:40:42.316" v="13" actId="20577"/>
        <pc:sldMkLst>
          <pc:docMk/>
          <pc:sldMk cId="1250419399" sldId="628"/>
        </pc:sldMkLst>
        <pc:spChg chg="mod">
          <ac:chgData name="齊藤 卓也" userId="535f7868ac294224" providerId="LiveId" clId="{9BDA931D-D391-4D52-8E92-27DD72B808DF}" dt="2021-08-29T09:40:37.537" v="9" actId="20577"/>
          <ac:spMkLst>
            <pc:docMk/>
            <pc:sldMk cId="1250419399" sldId="628"/>
            <ac:spMk id="14" creationId="{52CAB395-3264-4C47-9AAF-14049D6802AA}"/>
          </ac:spMkLst>
        </pc:spChg>
        <pc:spChg chg="mod">
          <ac:chgData name="齊藤 卓也" userId="535f7868ac294224" providerId="LiveId" clId="{9BDA931D-D391-4D52-8E92-27DD72B808DF}" dt="2021-08-29T09:40:42.316" v="13" actId="20577"/>
          <ac:spMkLst>
            <pc:docMk/>
            <pc:sldMk cId="1250419399" sldId="628"/>
            <ac:spMk id="16" creationId="{759349F1-3236-4531-86DF-F8608FC682D4}"/>
          </ac:spMkLst>
        </pc:spChg>
        <pc:spChg chg="mod">
          <ac:chgData name="齊藤 卓也" userId="535f7868ac294224" providerId="LiveId" clId="{9BDA931D-D391-4D52-8E92-27DD72B808DF}" dt="2021-08-29T09:40:40.029" v="11" actId="20577"/>
          <ac:spMkLst>
            <pc:docMk/>
            <pc:sldMk cId="1250419399" sldId="628"/>
            <ac:spMk id="21" creationId="{C32BEC80-C75D-4666-B927-AE33E1A01066}"/>
          </ac:spMkLst>
        </pc:spChg>
      </pc:sldChg>
      <pc:sldChg chg="modSp mod">
        <pc:chgData name="齊藤 卓也" userId="535f7868ac294224" providerId="LiveId" clId="{9BDA931D-D391-4D52-8E92-27DD72B808DF}" dt="2021-08-29T09:40:59.932" v="17" actId="20577"/>
        <pc:sldMkLst>
          <pc:docMk/>
          <pc:sldMk cId="2266497160" sldId="629"/>
        </pc:sldMkLst>
        <pc:spChg chg="mod">
          <ac:chgData name="齊藤 卓也" userId="535f7868ac294224" providerId="LiveId" clId="{9BDA931D-D391-4D52-8E92-27DD72B808DF}" dt="2021-08-29T09:40:57.233" v="15" actId="20577"/>
          <ac:spMkLst>
            <pc:docMk/>
            <pc:sldMk cId="2266497160" sldId="629"/>
            <ac:spMk id="9" creationId="{DAD5AFEF-3D44-4FF9-9A4B-B4BC810C9472}"/>
          </ac:spMkLst>
        </pc:spChg>
        <pc:spChg chg="mod">
          <ac:chgData name="齊藤 卓也" userId="535f7868ac294224" providerId="LiveId" clId="{9BDA931D-D391-4D52-8E92-27DD72B808DF}" dt="2021-08-29T09:40:59.932" v="17" actId="20577"/>
          <ac:spMkLst>
            <pc:docMk/>
            <pc:sldMk cId="2266497160" sldId="629"/>
            <ac:spMk id="10" creationId="{BB654C92-AB62-4519-A2AD-5C1227187648}"/>
          </ac:spMkLst>
        </pc:spChg>
      </pc:sldChg>
      <pc:sldChg chg="modSp mod">
        <pc:chgData name="齊藤 卓也" userId="535f7868ac294224" providerId="LiveId" clId="{9BDA931D-D391-4D52-8E92-27DD72B808DF}" dt="2021-08-29T09:41:27.946" v="32" actId="20577"/>
        <pc:sldMkLst>
          <pc:docMk/>
          <pc:sldMk cId="2931024107" sldId="630"/>
        </pc:sldMkLst>
        <pc:spChg chg="mod">
          <ac:chgData name="齊藤 卓也" userId="535f7868ac294224" providerId="LiveId" clId="{9BDA931D-D391-4D52-8E92-27DD72B808DF}" dt="2021-08-29T09:41:27.946" v="32" actId="20577"/>
          <ac:spMkLst>
            <pc:docMk/>
            <pc:sldMk cId="2931024107" sldId="630"/>
            <ac:spMk id="8" creationId="{7C1B70D0-6A5D-4B7A-BE3E-8F4CE1C74AFA}"/>
          </ac:spMkLst>
        </pc:spChg>
        <pc:spChg chg="mod">
          <ac:chgData name="齊藤 卓也" userId="535f7868ac294224" providerId="LiveId" clId="{9BDA931D-D391-4D52-8E92-27DD72B808DF}" dt="2021-08-29T09:41:25.357" v="30" actId="1038"/>
          <ac:spMkLst>
            <pc:docMk/>
            <pc:sldMk cId="2931024107" sldId="630"/>
            <ac:spMk id="11" creationId="{904E4AB7-5AB9-4B67-98BC-22BC3790CB08}"/>
          </ac:spMkLst>
        </pc:spChg>
      </pc:sldChg>
    </pc:docChg>
  </pc:docChgLst>
  <pc:docChgLst>
    <pc:chgData name="齊藤 卓也" userId="535f7868ac294224" providerId="LiveId" clId="{17F6F929-0F21-43E3-AB37-DCCB3CADC9B0}"/>
    <pc:docChg chg="modSld">
      <pc:chgData name="齊藤 卓也" userId="535f7868ac294224" providerId="LiveId" clId="{17F6F929-0F21-43E3-AB37-DCCB3CADC9B0}" dt="2021-08-25T00:02:48.382" v="23" actId="20577"/>
      <pc:docMkLst>
        <pc:docMk/>
      </pc:docMkLst>
      <pc:sldChg chg="modSp mod">
        <pc:chgData name="齊藤 卓也" userId="535f7868ac294224" providerId="LiveId" clId="{17F6F929-0F21-43E3-AB37-DCCB3CADC9B0}" dt="2021-08-25T00:02:48.382" v="23" actId="20577"/>
        <pc:sldMkLst>
          <pc:docMk/>
          <pc:sldMk cId="2112906168" sldId="257"/>
        </pc:sldMkLst>
        <pc:graphicFrameChg chg="modGraphic">
          <ac:chgData name="齊藤 卓也" userId="535f7868ac294224" providerId="LiveId" clId="{17F6F929-0F21-43E3-AB37-DCCB3CADC9B0}" dt="2021-08-25T00:02:48.382" v="23" actId="20577"/>
          <ac:graphicFrameMkLst>
            <pc:docMk/>
            <pc:sldMk cId="2112906168" sldId="257"/>
            <ac:graphicFrameMk id="9" creationId="{5D6CDEE2-A470-4345-BF0B-A48EFABB41E3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582" cy="49534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8971" y="0"/>
            <a:ext cx="2921582" cy="49534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71A534-700A-42DF-8DD7-2872B6B237EE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22963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212" y="4751219"/>
            <a:ext cx="5393690" cy="38873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7317"/>
            <a:ext cx="2921582" cy="49534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8971" y="9377317"/>
            <a:ext cx="2921582" cy="49534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80D4BB-E64D-4B88-AF72-6BE437A579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8751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4B38E9A-667B-4973-90E1-C71B771A31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3E3594E-CF7F-436B-ACDB-6FADB59817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D630CA9-E4B6-41A6-A329-B417C77BEA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4D2EDC-2E51-4106-B2E5-0CBCE6328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A04381-365A-408D-9FB6-74C32E0E9D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7617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9CFF80-425E-471B-AB7E-A63432EDBD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67AD7AB-1DD0-4696-B79F-84C8E4BF2D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1C70153-EC6C-45DE-9AA9-3B34755527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0575804-FB9C-478D-B760-1944636FA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75CA584-229F-400C-A2AE-343DDB13DF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5764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19514AD-8EC7-4B68-A675-97688A6318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00668A1-B74B-40BF-9572-6C7C30B246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F55A524-488A-4A59-8547-123E35F5DE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0CEDCD-841F-4E42-B5C2-40EFF2862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A2D6DFE-5ABB-45C5-9480-BC7759CA8B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2855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42EF045-3C63-421E-9B4F-C1F1B6EBA8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802D2F0-4420-4EB9-B003-2632729062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DC74530-2BBA-427B-9DEB-317F9AC6A3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206ACD5-4E4C-403E-B8DF-F6F393D25B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984EEC2-5E26-4E1E-8A4E-9B86AD8DF7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4257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1378C46-DAAB-4BAD-B8F9-7D86B7C533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4EA40E5-CF33-4B57-B984-3EA844459B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1F1416F-AF8E-4262-8777-27887DEF21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50231E9-6C54-4373-8DFD-1022AABA90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C040EA7-AA80-438F-B956-03625E8FE5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6731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EBEC19-5602-4375-8E21-409B9E3AF5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A70A6D0-564A-44D5-8D68-A4A44C4C16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E409F0D-994A-4678-ADE5-2F7ADEC06A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B713105-D5FE-4638-8252-8282265161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C965FA6-92B1-4EA2-A9A0-F25D15397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C4F66A6-581E-4A01-B3C5-8C2685A93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03205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1BA7D90-A3A0-4F84-BADC-830CC6EC65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B096C96-E919-4E81-9869-6E57E26434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7ECF7BD-34F0-4E36-BA67-1FB30FF26F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F3123D1-88E6-46AE-9E47-3642C17F4D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6AA0671-0574-4A69-A5D7-63703E3641B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668FEC3-E9E1-4198-B486-D2A16239B3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75AAB7C-7FEF-4421-9379-44335228B8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95CD5BE-8D6E-4EF7-ACE6-18548B2993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5705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AD9F1C-4961-4552-80E9-F3CF2BD07C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EF03519-0142-4EA8-A3DD-4385FD6D52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6C76E84-1158-4FC6-BC8D-A58F8AA1D3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874AF07-1F20-4076-B1A7-E45E2E27A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3383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152337A-210C-45B9-A849-B53AD704C3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2545A93-A069-45B3-8CB8-14152AFD3F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E9E29BC-3452-43C4-9BFD-087BC430E6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8798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E2C610-95D2-4128-84AB-A39EEE16FE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B5EAFA7-648E-4DC2-A529-0849F2DF39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278D988-CB95-46D9-AAB7-235B864196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5A492A6-8704-451F-9214-DC91F014E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25E18DC-F36F-459B-BD8C-B61763ED8A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4995346-B323-456D-B978-F21BFEB7A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7677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218205-E3F0-4394-91F7-FF9D51E61A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583BF4B-C5CF-4EA0-8086-A0FBE5AFC4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2F779AB-47FB-4943-B1FD-BC9E00E8FC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8EBF1D5-AD55-4B7C-A125-341158B8A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CA648B0-AAF4-48DC-95C7-EEB068B3AC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DF0BDA-C387-4885-89AF-8F21383F1C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2625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B8F6977-B47E-43E5-8AC0-6E16F8E3F8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79A4106-9220-4440-8B6C-4ABEE84D9C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E4C5DC-B2C7-4D4F-A3EE-8B3DF6BF35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0A5A9B3-C7E7-46FE-ADBE-1FAA9C76931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B1799A-1C54-416E-AEF1-3671A6638F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10297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A75E79CE-C082-4F3C-8B39-61B4058E720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375" b="13817"/>
          <a:stretch/>
        </p:blipFill>
        <p:spPr>
          <a:xfrm>
            <a:off x="1956621" y="542870"/>
            <a:ext cx="8078923" cy="5791924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1D21F52-B978-45EE-91C6-C7633F88A4E4}"/>
              </a:ext>
            </a:extLst>
          </p:cNvPr>
          <p:cNvSpPr txBox="1"/>
          <p:nvPr/>
        </p:nvSpPr>
        <p:spPr>
          <a:xfrm>
            <a:off x="328295" y="173538"/>
            <a:ext cx="825390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1 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03877230-36CD-4822-BD5B-07067B3B895F}"/>
              </a:ext>
            </a:extLst>
          </p:cNvPr>
          <p:cNvCxnSpPr/>
          <p:nvPr/>
        </p:nvCxnSpPr>
        <p:spPr>
          <a:xfrm>
            <a:off x="3632347" y="897195"/>
            <a:ext cx="0" cy="4748981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9EEFAFF4-4FF7-4288-A8A8-D3F48021BF8D}"/>
              </a:ext>
            </a:extLst>
          </p:cNvPr>
          <p:cNvCxnSpPr/>
          <p:nvPr/>
        </p:nvCxnSpPr>
        <p:spPr>
          <a:xfrm>
            <a:off x="8833611" y="907027"/>
            <a:ext cx="0" cy="4748981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D3F9969-E92D-40A1-9EFB-633E29E21A83}"/>
              </a:ext>
            </a:extLst>
          </p:cNvPr>
          <p:cNvSpPr txBox="1"/>
          <p:nvPr/>
        </p:nvSpPr>
        <p:spPr>
          <a:xfrm>
            <a:off x="1828102" y="660805"/>
            <a:ext cx="518091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9945F97-2E77-46E6-8AF9-C88DD53D876E}"/>
              </a:ext>
            </a:extLst>
          </p:cNvPr>
          <p:cNvSpPr txBox="1"/>
          <p:nvPr/>
        </p:nvSpPr>
        <p:spPr>
          <a:xfrm>
            <a:off x="1828101" y="1271181"/>
            <a:ext cx="518091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E15E055-4170-4CB0-82C4-35FCE3D6933E}"/>
              </a:ext>
            </a:extLst>
          </p:cNvPr>
          <p:cNvSpPr txBox="1"/>
          <p:nvPr/>
        </p:nvSpPr>
        <p:spPr>
          <a:xfrm>
            <a:off x="1828100" y="1881557"/>
            <a:ext cx="518091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B4CCE5B-089E-42C2-A5FC-F3E381E4FD6D}"/>
              </a:ext>
            </a:extLst>
          </p:cNvPr>
          <p:cNvSpPr txBox="1"/>
          <p:nvPr/>
        </p:nvSpPr>
        <p:spPr>
          <a:xfrm>
            <a:off x="1836590" y="2470815"/>
            <a:ext cx="518091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4940B4C-DCF0-45E9-922E-349026834AE9}"/>
              </a:ext>
            </a:extLst>
          </p:cNvPr>
          <p:cNvSpPr txBox="1"/>
          <p:nvPr/>
        </p:nvSpPr>
        <p:spPr>
          <a:xfrm>
            <a:off x="1828099" y="3060073"/>
            <a:ext cx="518091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43CF912-D454-40D6-8D21-F9A99195655C}"/>
              </a:ext>
            </a:extLst>
          </p:cNvPr>
          <p:cNvSpPr txBox="1"/>
          <p:nvPr/>
        </p:nvSpPr>
        <p:spPr>
          <a:xfrm>
            <a:off x="1828098" y="3649331"/>
            <a:ext cx="518091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7926965-4501-4C47-B7EF-FDB3897F9600}"/>
              </a:ext>
            </a:extLst>
          </p:cNvPr>
          <p:cNvSpPr txBox="1"/>
          <p:nvPr/>
        </p:nvSpPr>
        <p:spPr>
          <a:xfrm>
            <a:off x="1926415" y="4237783"/>
            <a:ext cx="351378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2102034-FAAC-4A53-A65D-3A92D4DB1138}"/>
              </a:ext>
            </a:extLst>
          </p:cNvPr>
          <p:cNvSpPr txBox="1"/>
          <p:nvPr/>
        </p:nvSpPr>
        <p:spPr>
          <a:xfrm>
            <a:off x="1698940" y="4830026"/>
            <a:ext cx="628698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7D4FC06-22F7-4C38-96C2-0F130069535E}"/>
              </a:ext>
            </a:extLst>
          </p:cNvPr>
          <p:cNvSpPr txBox="1"/>
          <p:nvPr/>
        </p:nvSpPr>
        <p:spPr>
          <a:xfrm>
            <a:off x="1693921" y="5420994"/>
            <a:ext cx="628698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4126419-989B-431B-AF31-5157B2106B55}"/>
              </a:ext>
            </a:extLst>
          </p:cNvPr>
          <p:cNvSpPr txBox="1"/>
          <p:nvPr/>
        </p:nvSpPr>
        <p:spPr>
          <a:xfrm rot="16200000">
            <a:off x="629192" y="3017105"/>
            <a:ext cx="17876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SUM (min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770EA32-85D7-41A7-B528-05D69E3C059E}"/>
              </a:ext>
            </a:extLst>
          </p:cNvPr>
          <p:cNvSpPr txBox="1"/>
          <p:nvPr/>
        </p:nvSpPr>
        <p:spPr>
          <a:xfrm>
            <a:off x="5155680" y="6401069"/>
            <a:ext cx="16882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 number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2C7C7B4-D597-4200-A026-BB02B7374BAA}"/>
              </a:ext>
            </a:extLst>
          </p:cNvPr>
          <p:cNvSpPr txBox="1"/>
          <p:nvPr/>
        </p:nvSpPr>
        <p:spPr>
          <a:xfrm>
            <a:off x="9117253" y="5823971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9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011AEC9-6877-40CB-B04C-F2B6636E204B}"/>
              </a:ext>
            </a:extLst>
          </p:cNvPr>
          <p:cNvSpPr txBox="1"/>
          <p:nvPr/>
        </p:nvSpPr>
        <p:spPr>
          <a:xfrm>
            <a:off x="8584488" y="5827612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04C3A5F-B96F-4F2E-B852-F2DBBB3B5DA6}"/>
              </a:ext>
            </a:extLst>
          </p:cNvPr>
          <p:cNvSpPr txBox="1"/>
          <p:nvPr/>
        </p:nvSpPr>
        <p:spPr>
          <a:xfrm>
            <a:off x="8044880" y="5816959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3DFE9AC-A4AB-4976-A7AC-6B6056AC5D84}"/>
              </a:ext>
            </a:extLst>
          </p:cNvPr>
          <p:cNvSpPr txBox="1"/>
          <p:nvPr/>
        </p:nvSpPr>
        <p:spPr>
          <a:xfrm>
            <a:off x="7512115" y="5824241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E1AFA585-57F6-4770-BF93-499DB9FC2271}"/>
              </a:ext>
            </a:extLst>
          </p:cNvPr>
          <p:cNvSpPr txBox="1"/>
          <p:nvPr/>
        </p:nvSpPr>
        <p:spPr>
          <a:xfrm>
            <a:off x="6959686" y="5816958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EC2D1F0D-6C3D-454D-9C0A-600E5E67F118}"/>
              </a:ext>
            </a:extLst>
          </p:cNvPr>
          <p:cNvSpPr txBox="1"/>
          <p:nvPr/>
        </p:nvSpPr>
        <p:spPr>
          <a:xfrm>
            <a:off x="6432191" y="5814409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4F5E7A49-BAEE-4C7F-93E9-43E868CACD08}"/>
              </a:ext>
            </a:extLst>
          </p:cNvPr>
          <p:cNvSpPr txBox="1"/>
          <p:nvPr/>
        </p:nvSpPr>
        <p:spPr>
          <a:xfrm>
            <a:off x="5899426" y="5823970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7A9C39C-2AA2-4E66-ACDC-A44146224A57}"/>
              </a:ext>
            </a:extLst>
          </p:cNvPr>
          <p:cNvSpPr txBox="1"/>
          <p:nvPr/>
        </p:nvSpPr>
        <p:spPr>
          <a:xfrm>
            <a:off x="5349528" y="5824241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D255E725-C403-439D-B3B5-E09794172308}"/>
              </a:ext>
            </a:extLst>
          </p:cNvPr>
          <p:cNvSpPr txBox="1"/>
          <p:nvPr/>
        </p:nvSpPr>
        <p:spPr>
          <a:xfrm>
            <a:off x="4797099" y="5814408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4EBBA65-3555-43BF-AF2F-01A2F0DD7684}"/>
              </a:ext>
            </a:extLst>
          </p:cNvPr>
          <p:cNvSpPr txBox="1"/>
          <p:nvPr/>
        </p:nvSpPr>
        <p:spPr>
          <a:xfrm>
            <a:off x="4281842" y="5823970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6B7CA6D-3D44-46CC-BBDD-E311387436CC}"/>
              </a:ext>
            </a:extLst>
          </p:cNvPr>
          <p:cNvSpPr txBox="1"/>
          <p:nvPr/>
        </p:nvSpPr>
        <p:spPr>
          <a:xfrm>
            <a:off x="3837184" y="5823970"/>
            <a:ext cx="338554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7DB6420A-84DB-4E12-BF2A-77834437030F}"/>
              </a:ext>
            </a:extLst>
          </p:cNvPr>
          <p:cNvSpPr txBox="1"/>
          <p:nvPr/>
        </p:nvSpPr>
        <p:spPr>
          <a:xfrm>
            <a:off x="3266391" y="5814407"/>
            <a:ext cx="338554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2EA57910-59A0-4170-92ED-68444CF7CF6A}"/>
              </a:ext>
            </a:extLst>
          </p:cNvPr>
          <p:cNvSpPr txBox="1"/>
          <p:nvPr/>
        </p:nvSpPr>
        <p:spPr>
          <a:xfrm>
            <a:off x="2774046" y="5814406"/>
            <a:ext cx="338554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01146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DF633777-24B4-49F9-A8B9-845E8E557AF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429" b="14152"/>
          <a:stretch/>
        </p:blipFill>
        <p:spPr>
          <a:xfrm>
            <a:off x="1899509" y="530942"/>
            <a:ext cx="8149060" cy="5758691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F4F3250-DD8D-4170-BBA3-0134202E31F8}"/>
              </a:ext>
            </a:extLst>
          </p:cNvPr>
          <p:cNvSpPr txBox="1"/>
          <p:nvPr/>
        </p:nvSpPr>
        <p:spPr>
          <a:xfrm>
            <a:off x="168186" y="176834"/>
            <a:ext cx="814535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2 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4EC5128B-9857-42B0-A4A2-7462718AC2DD}"/>
              </a:ext>
            </a:extLst>
          </p:cNvPr>
          <p:cNvCxnSpPr/>
          <p:nvPr/>
        </p:nvCxnSpPr>
        <p:spPr>
          <a:xfrm>
            <a:off x="5264503" y="894737"/>
            <a:ext cx="0" cy="4748981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03CBD50A-9F03-410A-9BEA-D17DA408F2C9}"/>
              </a:ext>
            </a:extLst>
          </p:cNvPr>
          <p:cNvCxnSpPr/>
          <p:nvPr/>
        </p:nvCxnSpPr>
        <p:spPr>
          <a:xfrm>
            <a:off x="8145354" y="894737"/>
            <a:ext cx="0" cy="4748981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9434182-C609-4AD6-9212-49894F3C5E40}"/>
              </a:ext>
            </a:extLst>
          </p:cNvPr>
          <p:cNvSpPr txBox="1"/>
          <p:nvPr/>
        </p:nvSpPr>
        <p:spPr>
          <a:xfrm>
            <a:off x="1848061" y="637137"/>
            <a:ext cx="518091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8D130B3-62A5-4132-9C0A-05844F09612E}"/>
              </a:ext>
            </a:extLst>
          </p:cNvPr>
          <p:cNvSpPr txBox="1"/>
          <p:nvPr/>
        </p:nvSpPr>
        <p:spPr>
          <a:xfrm>
            <a:off x="1848060" y="1366940"/>
            <a:ext cx="518091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721A13F-1988-491E-9CAD-A82A33AD5C12}"/>
              </a:ext>
            </a:extLst>
          </p:cNvPr>
          <p:cNvSpPr txBox="1"/>
          <p:nvPr/>
        </p:nvSpPr>
        <p:spPr>
          <a:xfrm>
            <a:off x="1848059" y="2019923"/>
            <a:ext cx="518091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EABFAB6-E0D4-40F3-BEC3-70469C5C5CCE}"/>
              </a:ext>
            </a:extLst>
          </p:cNvPr>
          <p:cNvSpPr txBox="1"/>
          <p:nvPr/>
        </p:nvSpPr>
        <p:spPr>
          <a:xfrm>
            <a:off x="1860181" y="2671786"/>
            <a:ext cx="518091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7D860E9-A4EC-4F12-AF6F-1F35C25A2C89}"/>
              </a:ext>
            </a:extLst>
          </p:cNvPr>
          <p:cNvSpPr txBox="1"/>
          <p:nvPr/>
        </p:nvSpPr>
        <p:spPr>
          <a:xfrm>
            <a:off x="1860180" y="3394527"/>
            <a:ext cx="518091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53651F3-CD4A-499E-A2A1-A87125A034AF}"/>
              </a:ext>
            </a:extLst>
          </p:cNvPr>
          <p:cNvSpPr txBox="1"/>
          <p:nvPr/>
        </p:nvSpPr>
        <p:spPr>
          <a:xfrm>
            <a:off x="1968736" y="4060594"/>
            <a:ext cx="351378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FEF254E-09B1-4322-BBD3-E0A80714E9CA}"/>
              </a:ext>
            </a:extLst>
          </p:cNvPr>
          <p:cNvSpPr txBox="1"/>
          <p:nvPr/>
        </p:nvSpPr>
        <p:spPr>
          <a:xfrm>
            <a:off x="1723082" y="4741100"/>
            <a:ext cx="628698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D6DA585-A556-4DEF-8D7E-5E2B76DB98D6}"/>
              </a:ext>
            </a:extLst>
          </p:cNvPr>
          <p:cNvSpPr txBox="1"/>
          <p:nvPr/>
        </p:nvSpPr>
        <p:spPr>
          <a:xfrm>
            <a:off x="1703204" y="5402218"/>
            <a:ext cx="628698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97F6262-5E61-4326-88DE-60649DD39D9C}"/>
              </a:ext>
            </a:extLst>
          </p:cNvPr>
          <p:cNvSpPr txBox="1"/>
          <p:nvPr/>
        </p:nvSpPr>
        <p:spPr>
          <a:xfrm rot="16200000">
            <a:off x="629192" y="3017105"/>
            <a:ext cx="17876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SUM (min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C9C3ABA-A4B8-4CBC-9FA4-77D2B5443653}"/>
              </a:ext>
            </a:extLst>
          </p:cNvPr>
          <p:cNvSpPr txBox="1"/>
          <p:nvPr/>
        </p:nvSpPr>
        <p:spPr>
          <a:xfrm>
            <a:off x="5155680" y="6401069"/>
            <a:ext cx="16882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 number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7C6F983-9D8A-42B7-93EA-2F264F21D2F5}"/>
              </a:ext>
            </a:extLst>
          </p:cNvPr>
          <p:cNvSpPr txBox="1"/>
          <p:nvPr/>
        </p:nvSpPr>
        <p:spPr>
          <a:xfrm>
            <a:off x="9117253" y="5823971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9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ED7586B-1A57-42A0-AD76-92E0305822F6}"/>
              </a:ext>
            </a:extLst>
          </p:cNvPr>
          <p:cNvSpPr txBox="1"/>
          <p:nvPr/>
        </p:nvSpPr>
        <p:spPr>
          <a:xfrm>
            <a:off x="8584488" y="5827612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25B9067-8A7A-4795-B1D2-8C008296258D}"/>
              </a:ext>
            </a:extLst>
          </p:cNvPr>
          <p:cNvSpPr txBox="1"/>
          <p:nvPr/>
        </p:nvSpPr>
        <p:spPr>
          <a:xfrm>
            <a:off x="8044880" y="5816959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BC29A19-8442-472C-87B8-3C1C40D53C96}"/>
              </a:ext>
            </a:extLst>
          </p:cNvPr>
          <p:cNvSpPr txBox="1"/>
          <p:nvPr/>
        </p:nvSpPr>
        <p:spPr>
          <a:xfrm>
            <a:off x="7512115" y="5824241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76C4C32-5298-44DD-91ED-0E68A150B237}"/>
              </a:ext>
            </a:extLst>
          </p:cNvPr>
          <p:cNvSpPr txBox="1"/>
          <p:nvPr/>
        </p:nvSpPr>
        <p:spPr>
          <a:xfrm>
            <a:off x="6959686" y="5816958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FB7B329-6081-49DB-9BB5-DFCB10602908}"/>
              </a:ext>
            </a:extLst>
          </p:cNvPr>
          <p:cNvSpPr txBox="1"/>
          <p:nvPr/>
        </p:nvSpPr>
        <p:spPr>
          <a:xfrm>
            <a:off x="6432191" y="5814409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B174A93-1A8C-4FA9-89B4-B18B005B367B}"/>
              </a:ext>
            </a:extLst>
          </p:cNvPr>
          <p:cNvSpPr txBox="1"/>
          <p:nvPr/>
        </p:nvSpPr>
        <p:spPr>
          <a:xfrm>
            <a:off x="5899426" y="5823970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EA6275F-BE5C-4F12-8576-DF5BEF1A6352}"/>
              </a:ext>
            </a:extLst>
          </p:cNvPr>
          <p:cNvSpPr txBox="1"/>
          <p:nvPr/>
        </p:nvSpPr>
        <p:spPr>
          <a:xfrm>
            <a:off x="5349528" y="5824241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639A274-315B-4851-8770-217243AE2C3B}"/>
              </a:ext>
            </a:extLst>
          </p:cNvPr>
          <p:cNvSpPr txBox="1"/>
          <p:nvPr/>
        </p:nvSpPr>
        <p:spPr>
          <a:xfrm>
            <a:off x="4797099" y="5814408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78B7F5C4-40A6-4BB9-ACD1-C47CBFD95BED}"/>
              </a:ext>
            </a:extLst>
          </p:cNvPr>
          <p:cNvSpPr txBox="1"/>
          <p:nvPr/>
        </p:nvSpPr>
        <p:spPr>
          <a:xfrm>
            <a:off x="4281842" y="5823970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D5FBA68-3E19-431F-9D02-2FB4F64D5BD8}"/>
              </a:ext>
            </a:extLst>
          </p:cNvPr>
          <p:cNvSpPr txBox="1"/>
          <p:nvPr/>
        </p:nvSpPr>
        <p:spPr>
          <a:xfrm>
            <a:off x="3837184" y="5823970"/>
            <a:ext cx="338554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4F46603A-208B-44BB-82B4-2F82B5B99BF5}"/>
              </a:ext>
            </a:extLst>
          </p:cNvPr>
          <p:cNvSpPr txBox="1"/>
          <p:nvPr/>
        </p:nvSpPr>
        <p:spPr>
          <a:xfrm>
            <a:off x="3266391" y="5814407"/>
            <a:ext cx="338554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B25D3F4C-50A7-49C4-9609-3B4785EF6887}"/>
              </a:ext>
            </a:extLst>
          </p:cNvPr>
          <p:cNvSpPr txBox="1"/>
          <p:nvPr/>
        </p:nvSpPr>
        <p:spPr>
          <a:xfrm>
            <a:off x="2774046" y="5814406"/>
            <a:ext cx="338554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24976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7DC0765C-E5DF-4D96-91C0-1D495375383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239" b="14824"/>
          <a:stretch/>
        </p:blipFill>
        <p:spPr>
          <a:xfrm>
            <a:off x="1995950" y="560442"/>
            <a:ext cx="8074671" cy="5712541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2240A5E-5AF0-42E0-89AB-2A333DF5CED1}"/>
              </a:ext>
            </a:extLst>
          </p:cNvPr>
          <p:cNvSpPr txBox="1"/>
          <p:nvPr/>
        </p:nvSpPr>
        <p:spPr>
          <a:xfrm>
            <a:off x="243444" y="164964"/>
            <a:ext cx="70955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</a:t>
            </a:r>
            <a:r>
              <a:rPr lang="en-US" altLang="ja-JP" b="1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233BD93D-DF6B-42AF-8C43-20F96FE280D7}"/>
              </a:ext>
            </a:extLst>
          </p:cNvPr>
          <p:cNvCxnSpPr/>
          <p:nvPr/>
        </p:nvCxnSpPr>
        <p:spPr>
          <a:xfrm>
            <a:off x="9236734" y="936524"/>
            <a:ext cx="0" cy="4748981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B3D585EB-DF2D-4C1A-B664-3E218D5C6D6D}"/>
              </a:ext>
            </a:extLst>
          </p:cNvPr>
          <p:cNvCxnSpPr/>
          <p:nvPr/>
        </p:nvCxnSpPr>
        <p:spPr>
          <a:xfrm>
            <a:off x="4595909" y="946356"/>
            <a:ext cx="0" cy="4748981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213A12A-7DFA-4083-B396-1363640DDC1B}"/>
              </a:ext>
            </a:extLst>
          </p:cNvPr>
          <p:cNvSpPr txBox="1"/>
          <p:nvPr/>
        </p:nvSpPr>
        <p:spPr>
          <a:xfrm>
            <a:off x="1867177" y="677531"/>
            <a:ext cx="518091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A713D0B-9A43-42E7-82AD-54F10A3AA410}"/>
              </a:ext>
            </a:extLst>
          </p:cNvPr>
          <p:cNvSpPr txBox="1"/>
          <p:nvPr/>
        </p:nvSpPr>
        <p:spPr>
          <a:xfrm>
            <a:off x="1867176" y="1669093"/>
            <a:ext cx="518091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B614A37-AD1F-400C-98C2-3BD63C515CD8}"/>
              </a:ext>
            </a:extLst>
          </p:cNvPr>
          <p:cNvSpPr txBox="1"/>
          <p:nvPr/>
        </p:nvSpPr>
        <p:spPr>
          <a:xfrm>
            <a:off x="1724507" y="5439283"/>
            <a:ext cx="628698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6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8405C21-7E91-43BB-A555-C0CC2B50B9D5}"/>
              </a:ext>
            </a:extLst>
          </p:cNvPr>
          <p:cNvSpPr txBox="1"/>
          <p:nvPr/>
        </p:nvSpPr>
        <p:spPr>
          <a:xfrm>
            <a:off x="1986351" y="2583161"/>
            <a:ext cx="351378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FB43B33-57B5-4E4A-AED4-222243C57C8C}"/>
              </a:ext>
            </a:extLst>
          </p:cNvPr>
          <p:cNvSpPr txBox="1"/>
          <p:nvPr/>
        </p:nvSpPr>
        <p:spPr>
          <a:xfrm>
            <a:off x="1724507" y="4489197"/>
            <a:ext cx="628698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4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F61FE80-1EF1-4783-9DFB-B0AA0457146D}"/>
              </a:ext>
            </a:extLst>
          </p:cNvPr>
          <p:cNvSpPr txBox="1"/>
          <p:nvPr/>
        </p:nvSpPr>
        <p:spPr>
          <a:xfrm>
            <a:off x="1739756" y="3536179"/>
            <a:ext cx="628698" cy="49244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0</a:t>
            </a:r>
            <a:endParaRPr lang="ja-JP" altLang="en-US" sz="2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2E74668-6AF7-4D7F-9EF1-2B1272EE0143}"/>
              </a:ext>
            </a:extLst>
          </p:cNvPr>
          <p:cNvSpPr txBox="1"/>
          <p:nvPr/>
        </p:nvSpPr>
        <p:spPr>
          <a:xfrm rot="16200000">
            <a:off x="629192" y="3017105"/>
            <a:ext cx="17876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SUM (min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D1BA122-9642-4D0A-B713-94E5F9722F29}"/>
              </a:ext>
            </a:extLst>
          </p:cNvPr>
          <p:cNvSpPr txBox="1"/>
          <p:nvPr/>
        </p:nvSpPr>
        <p:spPr>
          <a:xfrm>
            <a:off x="5155680" y="6401069"/>
            <a:ext cx="16882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 number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B7DF0CC-2171-4FB6-97BD-0F24C59DA34D}"/>
              </a:ext>
            </a:extLst>
          </p:cNvPr>
          <p:cNvSpPr txBox="1"/>
          <p:nvPr/>
        </p:nvSpPr>
        <p:spPr>
          <a:xfrm>
            <a:off x="9117253" y="5823971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9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AEE696D-3A4C-4ACB-80F7-134760BDE3B7}"/>
              </a:ext>
            </a:extLst>
          </p:cNvPr>
          <p:cNvSpPr txBox="1"/>
          <p:nvPr/>
        </p:nvSpPr>
        <p:spPr>
          <a:xfrm>
            <a:off x="8584488" y="5827612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B544F91-5519-4EDF-8E17-313D0D62D726}"/>
              </a:ext>
            </a:extLst>
          </p:cNvPr>
          <p:cNvSpPr txBox="1"/>
          <p:nvPr/>
        </p:nvSpPr>
        <p:spPr>
          <a:xfrm>
            <a:off x="8044880" y="5816959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E309B977-7EE6-40B6-A9D5-17648D53A2FE}"/>
              </a:ext>
            </a:extLst>
          </p:cNvPr>
          <p:cNvSpPr txBox="1"/>
          <p:nvPr/>
        </p:nvSpPr>
        <p:spPr>
          <a:xfrm>
            <a:off x="7512115" y="5824241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C417C200-2B4E-4107-B6AC-7DDAE28A25E6}"/>
              </a:ext>
            </a:extLst>
          </p:cNvPr>
          <p:cNvSpPr txBox="1"/>
          <p:nvPr/>
        </p:nvSpPr>
        <p:spPr>
          <a:xfrm>
            <a:off x="6959686" y="5816958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B5721C15-1C40-4258-A336-6DD6ACC79788}"/>
              </a:ext>
            </a:extLst>
          </p:cNvPr>
          <p:cNvSpPr txBox="1"/>
          <p:nvPr/>
        </p:nvSpPr>
        <p:spPr>
          <a:xfrm>
            <a:off x="6432191" y="5814409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92495734-305A-4D6C-936F-9170C87234A9}"/>
              </a:ext>
            </a:extLst>
          </p:cNvPr>
          <p:cNvSpPr txBox="1"/>
          <p:nvPr/>
        </p:nvSpPr>
        <p:spPr>
          <a:xfrm>
            <a:off x="5899426" y="5823970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76E1635-E1E7-4682-BBAA-83C61DB24B0F}"/>
              </a:ext>
            </a:extLst>
          </p:cNvPr>
          <p:cNvSpPr txBox="1"/>
          <p:nvPr/>
        </p:nvSpPr>
        <p:spPr>
          <a:xfrm>
            <a:off x="5349528" y="5824241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E037C7B-B117-42FB-B8C2-9F3D01FCFD9E}"/>
              </a:ext>
            </a:extLst>
          </p:cNvPr>
          <p:cNvSpPr txBox="1"/>
          <p:nvPr/>
        </p:nvSpPr>
        <p:spPr>
          <a:xfrm>
            <a:off x="4797099" y="5814408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18531E7E-EAA8-4792-9F05-944CD16777C3}"/>
              </a:ext>
            </a:extLst>
          </p:cNvPr>
          <p:cNvSpPr txBox="1"/>
          <p:nvPr/>
        </p:nvSpPr>
        <p:spPr>
          <a:xfrm>
            <a:off x="4281842" y="5823970"/>
            <a:ext cx="4924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DFF633B8-34BC-46B7-9DF2-B63D3D4C9E3A}"/>
              </a:ext>
            </a:extLst>
          </p:cNvPr>
          <p:cNvSpPr txBox="1"/>
          <p:nvPr/>
        </p:nvSpPr>
        <p:spPr>
          <a:xfrm>
            <a:off x="3837184" y="5823970"/>
            <a:ext cx="338554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FB72C5A8-46B4-438D-B50F-9EB3F8B79CFA}"/>
              </a:ext>
            </a:extLst>
          </p:cNvPr>
          <p:cNvSpPr txBox="1"/>
          <p:nvPr/>
        </p:nvSpPr>
        <p:spPr>
          <a:xfrm>
            <a:off x="3266391" y="5814407"/>
            <a:ext cx="338554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6CCF44B-E01B-4057-BA34-F1A579CBDAD3}"/>
              </a:ext>
            </a:extLst>
          </p:cNvPr>
          <p:cNvSpPr txBox="1"/>
          <p:nvPr/>
        </p:nvSpPr>
        <p:spPr>
          <a:xfrm>
            <a:off x="2774046" y="5814406"/>
            <a:ext cx="338554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06557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6</TotalTime>
  <Words>99</Words>
  <Application>Microsoft Office PowerPoint</Application>
  <PresentationFormat>ワイド画面</PresentationFormat>
  <Paragraphs>71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齊藤 卓也</dc:creator>
  <cp:lastModifiedBy>齊藤 卓也</cp:lastModifiedBy>
  <cp:revision>25</cp:revision>
  <cp:lastPrinted>2021-07-09T03:13:50Z</cp:lastPrinted>
  <dcterms:created xsi:type="dcterms:W3CDTF">2021-05-15T09:49:27Z</dcterms:created>
  <dcterms:modified xsi:type="dcterms:W3CDTF">2021-09-01T22:05:20Z</dcterms:modified>
</cp:coreProperties>
</file>